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60" r:id="rId4"/>
    <p:sldId id="261" r:id="rId5"/>
    <p:sldId id="262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2CAD531F-34F1-7A17-5CE8-1E7D301D6A6C}" name="Matt Croughan" initials="MC" userId="S-1-5-21-4194659375-3990950164-2721425262-1589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11" d="100"/>
          <a:sy n="111" d="100"/>
        </p:scale>
        <p:origin x="55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microsoft.com/office/2018/10/relationships/authors" Target="authors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pbs-fs\users\jkim\Desktop\PBS\Oxygen%20consumption%20rate\20240503_OCR%232\OCR%20calculation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sOUR measurement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1.5451881014873142E-2"/>
                  <c:y val="-0.27112650918635173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900" b="1" i="0" u="none" strike="noStrike" kern="1200" baseline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baseline="0" dirty="0"/>
                      <a:t>y = -0.93x + 919.83</a:t>
                    </a:r>
                    <a:br>
                      <a:rPr lang="en-US" baseline="0" dirty="0"/>
                    </a:br>
                    <a:r>
                      <a:rPr lang="en-US" baseline="0" dirty="0"/>
                      <a:t>R² = 0.99</a:t>
                    </a:r>
                    <a:endParaRPr lang="en-US" dirty="0"/>
                  </a:p>
                </c:rich>
              </c:tx>
              <c:numFmt formatCode="General" sourceLinked="0"/>
              <c:spPr>
                <a:solidFill>
                  <a:schemeClr val="bg1"/>
                </a:solidFill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1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Sheet1!$P$32:$P$49</c:f>
              <c:numCache>
                <c:formatCode>General</c:formatCode>
                <c:ptCount val="18"/>
                <c:pt idx="0">
                  <c:v>938.98333333083428</c:v>
                </c:pt>
                <c:pt idx="1">
                  <c:v>940.98333332687616</c:v>
                </c:pt>
                <c:pt idx="2">
                  <c:v>942.98333333339542</c:v>
                </c:pt>
                <c:pt idx="3">
                  <c:v>945</c:v>
                </c:pt>
                <c:pt idx="4">
                  <c:v>946.99999999604188</c:v>
                </c:pt>
                <c:pt idx="5">
                  <c:v>948.99999999208376</c:v>
                </c:pt>
                <c:pt idx="6">
                  <c:v>950.99999999860302</c:v>
                </c:pt>
                <c:pt idx="7">
                  <c:v>952.9999999946449</c:v>
                </c:pt>
                <c:pt idx="8">
                  <c:v>955.03333333181217</c:v>
                </c:pt>
                <c:pt idx="9">
                  <c:v>957.03333332785405</c:v>
                </c:pt>
                <c:pt idx="10">
                  <c:v>959.03333332389593</c:v>
                </c:pt>
                <c:pt idx="11">
                  <c:v>961.03333333041519</c:v>
                </c:pt>
                <c:pt idx="12">
                  <c:v>963.03333332645707</c:v>
                </c:pt>
                <c:pt idx="13">
                  <c:v>964.98333333176561</c:v>
                </c:pt>
                <c:pt idx="14">
                  <c:v>966.98333332780749</c:v>
                </c:pt>
                <c:pt idx="15">
                  <c:v>968.99999999441206</c:v>
                </c:pt>
                <c:pt idx="16">
                  <c:v>971.01666666101664</c:v>
                </c:pt>
                <c:pt idx="17">
                  <c:v>973.04999999818392</c:v>
                </c:pt>
              </c:numCache>
            </c:numRef>
          </c:xVal>
          <c:yVal>
            <c:numRef>
              <c:f>Sheet1!$Q$32:$Q$49</c:f>
              <c:numCache>
                <c:formatCode>General</c:formatCode>
                <c:ptCount val="18"/>
                <c:pt idx="0">
                  <c:v>40.345570000000002</c:v>
                </c:pt>
                <c:pt idx="1">
                  <c:v>38.858364000000002</c:v>
                </c:pt>
                <c:pt idx="2">
                  <c:v>37.260128000000002</c:v>
                </c:pt>
                <c:pt idx="3">
                  <c:v>35.628368000000002</c:v>
                </c:pt>
                <c:pt idx="4">
                  <c:v>33.943119000000003</c:v>
                </c:pt>
                <c:pt idx="5">
                  <c:v>32.088527999999997</c:v>
                </c:pt>
                <c:pt idx="6">
                  <c:v>30.146609999999999</c:v>
                </c:pt>
                <c:pt idx="7">
                  <c:v>28.17548</c:v>
                </c:pt>
                <c:pt idx="8">
                  <c:v>26.254619999999999</c:v>
                </c:pt>
                <c:pt idx="9">
                  <c:v>24.249389999999998</c:v>
                </c:pt>
                <c:pt idx="10">
                  <c:v>22.217361</c:v>
                </c:pt>
                <c:pt idx="11">
                  <c:v>20.191977999999999</c:v>
                </c:pt>
                <c:pt idx="12">
                  <c:v>18.221394</c:v>
                </c:pt>
                <c:pt idx="13">
                  <c:v>16.216434</c:v>
                </c:pt>
                <c:pt idx="14">
                  <c:v>14.396815999999999</c:v>
                </c:pt>
                <c:pt idx="15">
                  <c:v>12.743575999999999</c:v>
                </c:pt>
                <c:pt idx="16">
                  <c:v>11.105765999999999</c:v>
                </c:pt>
                <c:pt idx="17">
                  <c:v>9.703284999999999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94BB-4AC8-8505-31286CA8B81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9438719"/>
        <c:axId val="129434879"/>
      </c:scatterChart>
      <c:valAx>
        <c:axId val="129438719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 Time [min]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9434879"/>
        <c:crosses val="autoZero"/>
        <c:crossBetween val="midCat"/>
      </c:valAx>
      <c:valAx>
        <c:axId val="129434879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DO [%]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9438719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b="1"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A93405-A565-FAB0-B64C-7CF5CE57B0E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C388F78-9684-B614-877B-17529E11FFD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25A980-D81B-9906-912A-E623492C26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B4C16-95CD-4802-BA15-E9BD5DC4A917}" type="datetimeFigureOut">
              <a:rPr lang="en-US" smtClean="0"/>
              <a:t>3/2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97F300-66B6-D27A-2AE7-A3673D6243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F8C6C89-8615-66CD-03CE-A446D1D85D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6810D-BADB-4D3B-87AD-97A6E35C77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57268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486B6A-E250-F994-D453-D10FB8D891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22784B9-EC94-2057-BFCA-52CEEA7F0F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766C0C-33E2-43F0-A7E6-9760AC3C7F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B4C16-95CD-4802-BA15-E9BD5DC4A917}" type="datetimeFigureOut">
              <a:rPr lang="en-US" smtClean="0"/>
              <a:t>3/2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EB36AC-C7BF-CDFC-978C-56D34C4E59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057DDE-4B49-E732-8C1A-048F828A98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6810D-BADB-4D3B-87AD-97A6E35C77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14306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938FFFE-7762-404B-196C-6746FCDC359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EC9E277-6202-2578-EFBF-F8DADD0BA29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A0DE99-C3DF-1567-94E9-6F2C7650B1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B4C16-95CD-4802-BA15-E9BD5DC4A917}" type="datetimeFigureOut">
              <a:rPr lang="en-US" smtClean="0"/>
              <a:t>3/2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4139AD-5330-19CA-2575-79B7A3945D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5FDCF8-73DE-363F-C6B9-D0B676B61F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6810D-BADB-4D3B-87AD-97A6E35C77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69213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74327A-E778-E473-5B4F-DF5A0D3772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72D302D-E223-C7A2-748D-04C9C31BD9D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5C6119-E76E-A3A8-D9BD-CFC408A220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B4C16-95CD-4802-BA15-E9BD5DC4A917}" type="datetimeFigureOut">
              <a:rPr lang="en-US" smtClean="0"/>
              <a:t>3/2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B60806-39F3-D517-2C5B-A077EEAE24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995379-24CF-AD53-A95B-873A7CE540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6810D-BADB-4D3B-87AD-97A6E35C77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15965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CAAF20-7B9D-2168-5970-DFFEC58B7B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49622FD-9C71-6FF2-8688-DDA543B82D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EA686F-D32B-6852-DD12-224D134EA1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B4C16-95CD-4802-BA15-E9BD5DC4A917}" type="datetimeFigureOut">
              <a:rPr lang="en-US" smtClean="0"/>
              <a:t>3/2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BFC395-3F99-7AF0-FA7A-D79F4DC6CE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5A8E90-28F7-3DC3-C741-5F58B050D4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6810D-BADB-4D3B-87AD-97A6E35C77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74410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66DB74-CA7F-F2B3-3785-CE6A57531B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ED90FFC-1861-8388-9AE3-9F626EC83E4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B74698C-02CE-DB0F-1A15-D85F3AE60EF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4F149D9-FA91-D16F-478E-4CA26B61AC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B4C16-95CD-4802-BA15-E9BD5DC4A917}" type="datetimeFigureOut">
              <a:rPr lang="en-US" smtClean="0"/>
              <a:t>3/2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11EBB4E-71D3-3C47-A411-E91D7CBB0E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51EB8D7-9F66-5800-2544-95F45C6930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6810D-BADB-4D3B-87AD-97A6E35C77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75863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0B67F2-D67E-1C11-1AE5-7C8E6B1DBD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58DADB1-DD5F-646E-C852-55970995E9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8C8EFB2-517F-90DA-FADB-D41FB0FB3FE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78C62CF-B849-E69C-BBF3-F373EA04788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3CDC641-79A3-5831-0167-21AEB49D225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FD13563-D6B6-1D13-2878-AE595B00E2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B4C16-95CD-4802-BA15-E9BD5DC4A917}" type="datetimeFigureOut">
              <a:rPr lang="en-US" smtClean="0"/>
              <a:t>3/20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8ABD6E9-11A2-69AB-685D-C03926BDB5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4AA112C-4828-3CB5-94D2-5DC9E3EA90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6810D-BADB-4D3B-87AD-97A6E35C77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28268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4A358F-8840-1FDD-BF2E-986C2EC0C9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6318C36-D7D1-2C51-E48D-15AC0800AA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B4C16-95CD-4802-BA15-E9BD5DC4A917}" type="datetimeFigureOut">
              <a:rPr lang="en-US" smtClean="0"/>
              <a:t>3/20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5FCF78E-EA48-268D-58A0-7BAC4BC347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DBA67F9-B759-DB8F-E45D-865A660AD9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6810D-BADB-4D3B-87AD-97A6E35C77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52298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F270FA2-AE8B-26F3-87BB-254424839D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B4C16-95CD-4802-BA15-E9BD5DC4A917}" type="datetimeFigureOut">
              <a:rPr lang="en-US" smtClean="0"/>
              <a:t>3/20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8F2844C-B325-BBC6-9B12-14196D94D3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D4E978B-D86E-DA05-83EC-5DD397D193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6810D-BADB-4D3B-87AD-97A6E35C77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4660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4B0772-6715-13C9-57D5-E359E1C8A4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B8D8F11-4A3A-3136-2F3C-1BD73F89AD8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44CC757-C8E7-30CF-7C4A-FA5B2598DCB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52C74E7-68F5-9624-5EC2-BA85FDF181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B4C16-95CD-4802-BA15-E9BD5DC4A917}" type="datetimeFigureOut">
              <a:rPr lang="en-US" smtClean="0"/>
              <a:t>3/2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718E5E9-EEF6-B2DC-1750-E46ADA25E4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53F452E-6421-1118-D33E-F48C76EA8E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6810D-BADB-4D3B-87AD-97A6E35C77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99521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4132E7-8260-6158-E976-A064DB106E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7496679-1A8A-C6D7-6032-B12FE9C9C74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A7506F4-5898-4BF9-8591-3992EBDA53C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38ACE33-D293-5212-9BC8-EFE347E93A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B4C16-95CD-4802-BA15-E9BD5DC4A917}" type="datetimeFigureOut">
              <a:rPr lang="en-US" smtClean="0"/>
              <a:t>3/2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7A3AA2D-2234-0AA5-0C5B-64CEFA3CF1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7FBCBF8-024F-5465-6210-82AB5AF21E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6810D-BADB-4D3B-87AD-97A6E35C77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2071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E748183-82CB-7E9B-C57D-E786ACAACC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2473997-5711-3060-F9E4-CD59293B6A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DD118B-D0CF-2BFD-98A9-34AC2FB169A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E9B4C16-95CD-4802-BA15-E9BD5DC4A917}" type="datetimeFigureOut">
              <a:rPr lang="en-US" smtClean="0"/>
              <a:t>3/2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F2E556-CF98-1604-165C-AFE8290121B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B52397-5F37-7249-D010-3ACD643A065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D76810D-BADB-4D3B-87AD-97A6E35C77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30163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019ECE-AEA0-B9F9-4828-D32E525E8B8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32522" y="735496"/>
            <a:ext cx="11608903" cy="5201478"/>
          </a:xfrm>
        </p:spPr>
        <p:txBody>
          <a:bodyPr>
            <a:normAutofit/>
          </a:bodyPr>
          <a:lstStyle/>
          <a:p>
            <a:r>
              <a:rPr lang="en-US" sz="36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easurement of oxygen transfer rate and specific oxygen uptake rate of h-iPSC aggregates in vertical wheel bioreactors to predict maximum cell density before oxygen limitation</a:t>
            </a:r>
            <a:br>
              <a:rPr lang="en-US" sz="40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</a:br>
            <a:br>
              <a:rPr lang="en-US" sz="40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</a:br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James Kim, </a:t>
            </a:r>
            <a:r>
              <a:rPr lang="en-US" sz="1800" b="1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mokhowa</a:t>
            </a:r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gbojo, Sunghoon Jung, Matt Croughan</a:t>
            </a:r>
            <a:b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br>
              <a:rPr lang="en-US" sz="40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</a:br>
            <a:r>
              <a:rPr lang="en-US" sz="4400" dirty="0"/>
              <a:t>Supplementary Material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85351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8D8E0D95-A695-81B8-8AAB-0810E5AC2BC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33349266"/>
              </p:ext>
            </p:extLst>
          </p:nvPr>
        </p:nvGraphicFramePr>
        <p:xfrm>
          <a:off x="1468134" y="823240"/>
          <a:ext cx="4381500" cy="13335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09600">
                  <a:extLst>
                    <a:ext uri="{9D8B030D-6E8A-4147-A177-3AD203B41FA5}">
                      <a16:colId xmlns:a16="http://schemas.microsoft.com/office/drawing/2014/main" val="2447648054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62929825"/>
                    </a:ext>
                  </a:extLst>
                </a:gridCol>
                <a:gridCol w="723900">
                  <a:extLst>
                    <a:ext uri="{9D8B030D-6E8A-4147-A177-3AD203B41FA5}">
                      <a16:colId xmlns:a16="http://schemas.microsoft.com/office/drawing/2014/main" val="1746071545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995522980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959618499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539052227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66416380"/>
                    </a:ext>
                  </a:extLst>
                </a:gridCol>
              </a:tblGrid>
              <a:tr h="190500">
                <a:tc rowSpan="2" gridSpan="2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La</a:t>
                      </a:r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measured in PBS 3 (2L WV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s Flow Rate [LPM]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00218497"/>
                  </a:ext>
                </a:extLst>
              </a:tr>
              <a:tr h="190500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625456244"/>
                  </a:ext>
                </a:extLst>
              </a:tr>
              <a:tr h="190500">
                <a:tc rowSpan="5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itation rate [rpm]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vert="vert27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8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5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48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797376593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4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8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6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3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7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474078011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5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22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520418697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8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7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6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6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48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094400521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1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2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36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982815287"/>
                  </a:ext>
                </a:extLst>
              </a:tr>
            </a:tbl>
          </a:graphicData>
        </a:graphic>
      </p:graphicFrame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5EA37447-2B32-3A18-B18F-9D3317C2D64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25308173"/>
              </p:ext>
            </p:extLst>
          </p:nvPr>
        </p:nvGraphicFramePr>
        <p:xfrm>
          <a:off x="6608064" y="823240"/>
          <a:ext cx="4381500" cy="13335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09600">
                  <a:extLst>
                    <a:ext uri="{9D8B030D-6E8A-4147-A177-3AD203B41FA5}">
                      <a16:colId xmlns:a16="http://schemas.microsoft.com/office/drawing/2014/main" val="641453829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527402656"/>
                    </a:ext>
                  </a:extLst>
                </a:gridCol>
                <a:gridCol w="723900">
                  <a:extLst>
                    <a:ext uri="{9D8B030D-6E8A-4147-A177-3AD203B41FA5}">
                      <a16:colId xmlns:a16="http://schemas.microsoft.com/office/drawing/2014/main" val="3702160267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139947368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87440008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905421906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59153505"/>
                    </a:ext>
                  </a:extLst>
                </a:gridCol>
              </a:tblGrid>
              <a:tr h="190500">
                <a:tc rowSpan="2" gridSpan="2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La</a:t>
                      </a:r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measured in PBS 3 (3L WV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s Flow Rate [LPM]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14303714"/>
                  </a:ext>
                </a:extLst>
              </a:tr>
              <a:tr h="190500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4074420"/>
                  </a:ext>
                </a:extLst>
              </a:tr>
              <a:tr h="190500">
                <a:tc rowSpan="5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itation rate [rpm]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vert="vert27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9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2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34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24138578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1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1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3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2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94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144474942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7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5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3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2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64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76594513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1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9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7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9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9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237962754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7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8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5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62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089427734"/>
                  </a:ext>
                </a:extLst>
              </a:tr>
            </a:tbl>
          </a:graphicData>
        </a:graphic>
      </p:graphicFrame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EC4E6E06-C0B5-DB85-639C-667F26D17E9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27826061"/>
              </p:ext>
            </p:extLst>
          </p:nvPr>
        </p:nvGraphicFramePr>
        <p:xfrm>
          <a:off x="1468134" y="2407641"/>
          <a:ext cx="4381500" cy="13335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09600">
                  <a:extLst>
                    <a:ext uri="{9D8B030D-6E8A-4147-A177-3AD203B41FA5}">
                      <a16:colId xmlns:a16="http://schemas.microsoft.com/office/drawing/2014/main" val="3351395221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556527526"/>
                    </a:ext>
                  </a:extLst>
                </a:gridCol>
                <a:gridCol w="723900">
                  <a:extLst>
                    <a:ext uri="{9D8B030D-6E8A-4147-A177-3AD203B41FA5}">
                      <a16:colId xmlns:a16="http://schemas.microsoft.com/office/drawing/2014/main" val="2901580291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965153467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65675707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4263344966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229184695"/>
                    </a:ext>
                  </a:extLst>
                </a:gridCol>
              </a:tblGrid>
              <a:tr h="190500">
                <a:tc rowSpan="2" gridSpan="2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La</a:t>
                      </a:r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measured in PBS 15 (10L WV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s Flow Rate [LPM]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68663948"/>
                  </a:ext>
                </a:extLst>
              </a:tr>
              <a:tr h="190500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420317149"/>
                  </a:ext>
                </a:extLst>
              </a:tr>
              <a:tr h="190500">
                <a:tc rowSpan="5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itation rate [rpm]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vert="vert27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5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8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5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5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698348672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0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0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0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2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228346409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5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4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8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4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8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974538085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1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4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1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6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3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033016243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5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12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3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5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7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012829835"/>
                  </a:ext>
                </a:extLst>
              </a:tr>
            </a:tbl>
          </a:graphicData>
        </a:graphic>
      </p:graphicFrame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A69BEAAE-D21D-68F8-03ED-EDE4C0EB7C0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61201473"/>
              </p:ext>
            </p:extLst>
          </p:nvPr>
        </p:nvGraphicFramePr>
        <p:xfrm>
          <a:off x="6608062" y="2407641"/>
          <a:ext cx="4381500" cy="13335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09600">
                  <a:extLst>
                    <a:ext uri="{9D8B030D-6E8A-4147-A177-3AD203B41FA5}">
                      <a16:colId xmlns:a16="http://schemas.microsoft.com/office/drawing/2014/main" val="3142716795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700734866"/>
                    </a:ext>
                  </a:extLst>
                </a:gridCol>
                <a:gridCol w="723900">
                  <a:extLst>
                    <a:ext uri="{9D8B030D-6E8A-4147-A177-3AD203B41FA5}">
                      <a16:colId xmlns:a16="http://schemas.microsoft.com/office/drawing/2014/main" val="468965924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977821757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442965083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660911298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4173560526"/>
                    </a:ext>
                  </a:extLst>
                </a:gridCol>
              </a:tblGrid>
              <a:tr h="190500">
                <a:tc rowSpan="2" gridSpan="2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La</a:t>
                      </a:r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measured in PBS 15 (15L WV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s Flow Rate [LPM]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47164448"/>
                  </a:ext>
                </a:extLst>
              </a:tr>
              <a:tr h="190500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702093521"/>
                  </a:ext>
                </a:extLst>
              </a:tr>
              <a:tr h="190500">
                <a:tc rowSpan="5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itation rate [rpm]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vert="vert27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0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1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4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3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3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737107341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9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0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9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9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0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811750804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4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4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3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935121269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1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1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2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8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208294457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6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8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2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8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6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547045569"/>
                  </a:ext>
                </a:extLst>
              </a:tr>
            </a:tbl>
          </a:graphicData>
        </a:graphic>
      </p:graphicFrame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4DCBB23A-E487-9154-98C6-060B73CD493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67455837"/>
              </p:ext>
            </p:extLst>
          </p:nvPr>
        </p:nvGraphicFramePr>
        <p:xfrm>
          <a:off x="1468134" y="3969868"/>
          <a:ext cx="3162300" cy="13335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09600">
                  <a:extLst>
                    <a:ext uri="{9D8B030D-6E8A-4147-A177-3AD203B41FA5}">
                      <a16:colId xmlns:a16="http://schemas.microsoft.com/office/drawing/2014/main" val="1483335445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220912931"/>
                    </a:ext>
                  </a:extLst>
                </a:gridCol>
                <a:gridCol w="723900">
                  <a:extLst>
                    <a:ext uri="{9D8B030D-6E8A-4147-A177-3AD203B41FA5}">
                      <a16:colId xmlns:a16="http://schemas.microsoft.com/office/drawing/2014/main" val="2355989004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970665021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078508615"/>
                    </a:ext>
                  </a:extLst>
                </a:gridCol>
              </a:tblGrid>
              <a:tr h="190500">
                <a:tc rowSpan="2" grid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La</a:t>
                      </a:r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measured in PBS 80 (50L WV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s Flow Rate [LPM]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6249075"/>
                  </a:ext>
                </a:extLst>
              </a:tr>
              <a:tr h="190500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249353982"/>
                  </a:ext>
                </a:extLst>
              </a:tr>
              <a:tr h="190500">
                <a:tc rowSpan="5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itation rate [rpm]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vert="vert27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3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6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6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235661892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2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6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3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628680395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1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3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6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94428134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2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3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1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794764324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9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6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8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015048547"/>
                  </a:ext>
                </a:extLst>
              </a:tr>
            </a:tbl>
          </a:graphicData>
        </a:graphic>
      </p:graphicFrame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A1FB2F30-8196-48AA-7F5E-962B800BA74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96187492"/>
              </p:ext>
            </p:extLst>
          </p:nvPr>
        </p:nvGraphicFramePr>
        <p:xfrm>
          <a:off x="6608062" y="3992042"/>
          <a:ext cx="3162300" cy="13335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09600">
                  <a:extLst>
                    <a:ext uri="{9D8B030D-6E8A-4147-A177-3AD203B41FA5}">
                      <a16:colId xmlns:a16="http://schemas.microsoft.com/office/drawing/2014/main" val="4153768724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337373386"/>
                    </a:ext>
                  </a:extLst>
                </a:gridCol>
                <a:gridCol w="723900">
                  <a:extLst>
                    <a:ext uri="{9D8B030D-6E8A-4147-A177-3AD203B41FA5}">
                      <a16:colId xmlns:a16="http://schemas.microsoft.com/office/drawing/2014/main" val="2645644214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346705019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671851487"/>
                    </a:ext>
                  </a:extLst>
                </a:gridCol>
              </a:tblGrid>
              <a:tr h="190500">
                <a:tc rowSpan="2" grid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La</a:t>
                      </a:r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measured in PBS 80 (80L WV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s Flow Rate [LPM]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96382234"/>
                  </a:ext>
                </a:extLst>
              </a:tr>
              <a:tr h="190500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6182912"/>
                  </a:ext>
                </a:extLst>
              </a:tr>
              <a:tr h="190500">
                <a:tc rowSpan="5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itation rate [rpm]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vert="vert27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679833625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4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720759941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9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7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221479913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8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9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291874682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7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6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7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967311320"/>
                  </a:ext>
                </a:extLst>
              </a:tr>
            </a:tbl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7A4E7305-1092-CE80-FC73-232B6148521A}"/>
              </a:ext>
            </a:extLst>
          </p:cNvPr>
          <p:cNvSpPr txBox="1"/>
          <p:nvPr/>
        </p:nvSpPr>
        <p:spPr>
          <a:xfrm>
            <a:off x="896112" y="823240"/>
            <a:ext cx="5052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</a:t>
            </a:r>
            <a:r>
              <a:rPr lang="en-US" b="1" dirty="0"/>
              <a:t>a</a:t>
            </a:r>
            <a:r>
              <a:rPr lang="en-US" dirty="0"/>
              <a:t>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BF32F73-2532-2703-2D91-68CD9DC9C5CE}"/>
              </a:ext>
            </a:extLst>
          </p:cNvPr>
          <p:cNvSpPr txBox="1"/>
          <p:nvPr/>
        </p:nvSpPr>
        <p:spPr>
          <a:xfrm>
            <a:off x="5996820" y="823240"/>
            <a:ext cx="5052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</a:t>
            </a:r>
            <a:r>
              <a:rPr lang="en-US" b="1" dirty="0"/>
              <a:t>b</a:t>
            </a:r>
            <a:r>
              <a:rPr lang="en-US" dirty="0"/>
              <a:t>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0CBD16D-D8A3-7167-F4A3-0E75A9B437AA}"/>
              </a:ext>
            </a:extLst>
          </p:cNvPr>
          <p:cNvSpPr txBox="1"/>
          <p:nvPr/>
        </p:nvSpPr>
        <p:spPr>
          <a:xfrm>
            <a:off x="896112" y="2407641"/>
            <a:ext cx="5052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</a:t>
            </a:r>
            <a:r>
              <a:rPr lang="en-US" b="1" dirty="0"/>
              <a:t>c</a:t>
            </a:r>
            <a:r>
              <a:rPr lang="en-US" dirty="0"/>
              <a:t>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D38F409-F311-3D72-7329-9BDFC62612CA}"/>
              </a:ext>
            </a:extLst>
          </p:cNvPr>
          <p:cNvSpPr txBox="1"/>
          <p:nvPr/>
        </p:nvSpPr>
        <p:spPr>
          <a:xfrm>
            <a:off x="5996820" y="2407641"/>
            <a:ext cx="5052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</a:t>
            </a:r>
            <a:r>
              <a:rPr lang="en-US" b="1" dirty="0"/>
              <a:t>d</a:t>
            </a:r>
            <a:r>
              <a:rPr lang="en-US" dirty="0"/>
              <a:t>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790D1B5-05E1-5850-3ED0-ACFABE362F80}"/>
              </a:ext>
            </a:extLst>
          </p:cNvPr>
          <p:cNvSpPr txBox="1"/>
          <p:nvPr/>
        </p:nvSpPr>
        <p:spPr>
          <a:xfrm>
            <a:off x="896112" y="3996597"/>
            <a:ext cx="5052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</a:t>
            </a:r>
            <a:r>
              <a:rPr lang="en-US" b="1" dirty="0"/>
              <a:t>e</a:t>
            </a:r>
            <a:r>
              <a:rPr lang="en-US" dirty="0"/>
              <a:t>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CC2F17A-4407-68DC-2D6B-D48C0D235FAA}"/>
              </a:ext>
            </a:extLst>
          </p:cNvPr>
          <p:cNvSpPr txBox="1"/>
          <p:nvPr/>
        </p:nvSpPr>
        <p:spPr>
          <a:xfrm>
            <a:off x="5996820" y="4177886"/>
            <a:ext cx="5052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</a:t>
            </a:r>
            <a:r>
              <a:rPr lang="en-US" b="1" dirty="0"/>
              <a:t>f</a:t>
            </a:r>
            <a:r>
              <a:rPr lang="en-US" dirty="0"/>
              <a:t>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76DEB05-1EF2-DCE5-D86E-42702132DFF5}"/>
              </a:ext>
            </a:extLst>
          </p:cNvPr>
          <p:cNvSpPr txBox="1"/>
          <p:nvPr/>
        </p:nvSpPr>
        <p:spPr>
          <a:xfrm>
            <a:off x="1468134" y="5586984"/>
            <a:ext cx="95214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1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Summary of the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La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easured in PBS 3 at (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2L , (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3L, PBS 15 at (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10L, (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15L, PBS 80 at (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50L and (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80L working volume.</a:t>
            </a:r>
          </a:p>
        </p:txBody>
      </p:sp>
    </p:spTree>
    <p:extLst>
      <p:ext uri="{BB962C8B-B14F-4D97-AF65-F5344CB8AC3E}">
        <p14:creationId xmlns:p14="http://schemas.microsoft.com/office/powerpoint/2010/main" val="8556375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2B67200-6393-EF2E-8AB5-77796B914B6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>
            <a:extLst>
              <a:ext uri="{FF2B5EF4-FFF2-40B4-BE49-F238E27FC236}">
                <a16:creationId xmlns:a16="http://schemas.microsoft.com/office/drawing/2014/main" id="{5F68FDFB-E873-268F-5EEB-B500EF090D91}"/>
              </a:ext>
            </a:extLst>
          </p:cNvPr>
          <p:cNvSpPr txBox="1"/>
          <p:nvPr/>
        </p:nvSpPr>
        <p:spPr>
          <a:xfrm>
            <a:off x="1942803" y="4928303"/>
            <a:ext cx="853047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Calculation of the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UR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iPSCs through measuring the rate of change in DO in gas-tight PBS mini 0.1 bioreactor.</a:t>
            </a:r>
          </a:p>
        </p:txBody>
      </p:sp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5CF05043-8EC1-A66F-3143-650C92004E8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66843397"/>
              </p:ext>
            </p:extLst>
          </p:nvPr>
        </p:nvGraphicFramePr>
        <p:xfrm>
          <a:off x="3839397" y="405044"/>
          <a:ext cx="4572000" cy="2857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mc:AlternateContent xmlns:mc="http://schemas.openxmlformats.org/markup-compatibility/2006" xmlns:a14="http://schemas.microsoft.com/office/drawing/2010/main">
        <mc:Choice Requires="a14"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106A69B4-B2EE-FD7F-6AE0-2406EE274440}"/>
                  </a:ext>
                </a:extLst>
              </p:cNvPr>
              <p:cNvSpPr txBox="1"/>
              <p:nvPr/>
            </p:nvSpPr>
            <p:spPr>
              <a:xfrm>
                <a:off x="2404785" y="3262544"/>
                <a:ext cx="7606506" cy="1262974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14:m>
                  <m:oMath xmlns:m="http://schemas.openxmlformats.org/officeDocument/2006/math">
                    <m:r>
                      <a:rPr lang="en-US" b="0" i="1" smtClean="0">
                        <a:latin typeface="Cambria Math" panose="02040503050406030204" pitchFamily="18" charset="0"/>
                      </a:rPr>
                      <m:t>0.93</m:t>
                    </m:r>
                    <m:f>
                      <m:fPr>
                        <m:ctrlPr>
                          <a:rPr lang="en-US" b="0" i="1" smtClean="0">
                            <a:latin typeface="Cambria Math" panose="02040503050406030204" pitchFamily="18" charset="0"/>
                          </a:rPr>
                        </m:ctrlPr>
                      </m:fPr>
                      <m:num>
                        <m:r>
                          <a:rPr lang="en-US" b="0" i="1" smtClean="0">
                            <a:latin typeface="Cambria Math" panose="02040503050406030204" pitchFamily="18" charset="0"/>
                          </a:rPr>
                          <m:t>𝐷𝑂</m:t>
                        </m:r>
                        <m:r>
                          <a:rPr lang="en-US" b="0" i="1" smtClean="0">
                            <a:latin typeface="Cambria Math" panose="02040503050406030204" pitchFamily="18" charset="0"/>
                          </a:rPr>
                          <m:t> [%]</m:t>
                        </m:r>
                      </m:num>
                      <m:den>
                        <m:r>
                          <a:rPr lang="en-US" b="0" i="1" smtClean="0">
                            <a:latin typeface="Cambria Math" panose="02040503050406030204" pitchFamily="18" charset="0"/>
                          </a:rPr>
                          <m:t>𝑚𝑖𝑛</m:t>
                        </m:r>
                      </m:den>
                    </m:f>
                    <m:r>
                      <a:rPr lang="en-US" b="0" i="1" smtClean="0">
                        <a:latin typeface="Cambria Math" panose="02040503050406030204" pitchFamily="18" charset="0"/>
                      </a:rPr>
                      <m:t>∗</m:t>
                    </m:r>
                    <m:f>
                      <m:fPr>
                        <m:ctrlPr>
                          <a:rPr lang="en-US" b="0" i="1" smtClean="0">
                            <a:latin typeface="Cambria Math" panose="02040503050406030204" pitchFamily="18" charset="0"/>
                          </a:rPr>
                        </m:ctrlPr>
                      </m:fPr>
                      <m:num>
                        <m:r>
                          <a:rPr lang="en-US" b="0" i="1" smtClean="0">
                            <a:latin typeface="Cambria Math" panose="02040503050406030204" pitchFamily="18" charset="0"/>
                          </a:rPr>
                          <m:t>2.80∗</m:t>
                        </m:r>
                        <m:sSup>
                          <m:sSupPr>
                            <m:ctrlPr>
                              <a:rPr lang="en-US" b="0" i="1" smtClean="0">
                                <a:latin typeface="Cambria Math" panose="02040503050406030204" pitchFamily="18" charset="0"/>
                              </a:rPr>
                            </m:ctrlPr>
                          </m:sSupPr>
                          <m:e>
                            <m:r>
                              <a:rPr lang="en-US" b="0" i="1" smtClean="0">
                                <a:latin typeface="Cambria Math" panose="02040503050406030204" pitchFamily="18" charset="0"/>
                              </a:rPr>
                              <m:t>10</m:t>
                            </m:r>
                          </m:e>
                          <m:sup>
                            <m:r>
                              <a:rPr lang="en-US" b="0" i="1" smtClean="0">
                                <a:latin typeface="Cambria Math" panose="02040503050406030204" pitchFamily="18" charset="0"/>
                              </a:rPr>
                              <m:t>−5</m:t>
                            </m:r>
                          </m:sup>
                        </m:sSup>
                        <m:r>
                          <a:rPr lang="en-US" b="0" i="1" smtClean="0">
                            <a:latin typeface="Cambria Math" panose="02040503050406030204" pitchFamily="18" charset="0"/>
                          </a:rPr>
                          <m:t>𝑚𝑜𝑙</m:t>
                        </m:r>
                        <m:r>
                          <a:rPr lang="en-US" b="0" i="1" smtClean="0">
                            <a:latin typeface="Cambria Math" panose="02040503050406030204" pitchFamily="18" charset="0"/>
                          </a:rPr>
                          <m:t> </m:t>
                        </m:r>
                        <m:sSub>
                          <m:sSubPr>
                            <m:ctrlPr>
                              <a:rPr lang="en-US" b="0" i="1" smtClean="0"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US" b="0" i="1" smtClean="0">
                                <a:latin typeface="Cambria Math" panose="02040503050406030204" pitchFamily="18" charset="0"/>
                              </a:rPr>
                              <m:t>𝑂</m:t>
                            </m:r>
                          </m:e>
                          <m:sub>
                            <m:r>
                              <a:rPr lang="en-US" b="0" i="1" smtClean="0">
                                <a:latin typeface="Cambria Math" panose="02040503050406030204" pitchFamily="18" charset="0"/>
                              </a:rPr>
                              <m:t>2</m:t>
                            </m:r>
                          </m:sub>
                        </m:sSub>
                      </m:num>
                      <m:den>
                        <m:r>
                          <a:rPr lang="en-US" b="0" i="1" smtClean="0">
                            <a:latin typeface="Cambria Math" panose="02040503050406030204" pitchFamily="18" charset="0"/>
                          </a:rPr>
                          <m:t>1 </m:t>
                        </m:r>
                        <m:r>
                          <a:rPr lang="en-US" b="0" i="1" smtClean="0">
                            <a:latin typeface="Cambria Math" panose="02040503050406030204" pitchFamily="18" charset="0"/>
                          </a:rPr>
                          <m:t>𝐷𝑂</m:t>
                        </m:r>
                        <m:d>
                          <m:dPr>
                            <m:begChr m:val="["/>
                            <m:endChr m:val="]"/>
                            <m:ctrlPr>
                              <a:rPr lang="en-US" b="0" i="1" smtClean="0">
                                <a:latin typeface="Cambria Math" panose="02040503050406030204" pitchFamily="18" charset="0"/>
                              </a:rPr>
                            </m:ctrlPr>
                          </m:dPr>
                          <m:e>
                            <m:r>
                              <a:rPr lang="en-US" b="0" i="1" smtClean="0">
                                <a:latin typeface="Cambria Math" panose="02040503050406030204" pitchFamily="18" charset="0"/>
                              </a:rPr>
                              <m:t>%</m:t>
                            </m:r>
                          </m:e>
                        </m:d>
                      </m:den>
                    </m:f>
                    <m:r>
                      <a:rPr lang="en-US" b="0" i="1" smtClean="0">
                        <a:latin typeface="Cambria Math" panose="02040503050406030204" pitchFamily="18" charset="0"/>
                      </a:rPr>
                      <m:t>=2.75∗</m:t>
                    </m:r>
                    <m:sSup>
                      <m:sSupPr>
                        <m:ctrlPr>
                          <a:rPr lang="en-US" b="0" i="1" smtClean="0">
                            <a:latin typeface="Cambria Math" panose="02040503050406030204" pitchFamily="18" charset="0"/>
                          </a:rPr>
                        </m:ctrlPr>
                      </m:sSupPr>
                      <m:e>
                        <m:r>
                          <a:rPr lang="en-US" b="0" i="1" smtClean="0">
                            <a:latin typeface="Cambria Math" panose="02040503050406030204" pitchFamily="18" charset="0"/>
                          </a:rPr>
                          <m:t>10</m:t>
                        </m:r>
                      </m:e>
                      <m:sup>
                        <m:r>
                          <a:rPr lang="en-US" b="0" i="1" smtClean="0">
                            <a:latin typeface="Cambria Math" panose="02040503050406030204" pitchFamily="18" charset="0"/>
                          </a:rPr>
                          <m:t>−7</m:t>
                        </m:r>
                      </m:sup>
                    </m:sSup>
                    <m:f>
                      <m:fPr>
                        <m:ctrlPr>
                          <a:rPr lang="en-US" b="0" i="1" smtClean="0">
                            <a:latin typeface="Cambria Math" panose="02040503050406030204" pitchFamily="18" charset="0"/>
                          </a:rPr>
                        </m:ctrlPr>
                      </m:fPr>
                      <m:num>
                        <m:r>
                          <a:rPr lang="en-US" b="0" i="1" smtClean="0">
                            <a:latin typeface="Cambria Math" panose="02040503050406030204" pitchFamily="18" charset="0"/>
                          </a:rPr>
                          <m:t>𝑚𝑜𝑙</m:t>
                        </m:r>
                        <m:r>
                          <a:rPr lang="en-US" b="0" i="1" smtClean="0">
                            <a:latin typeface="Cambria Math" panose="02040503050406030204" pitchFamily="18" charset="0"/>
                          </a:rPr>
                          <m:t> </m:t>
                        </m:r>
                        <m:sSub>
                          <m:sSubPr>
                            <m:ctrlPr>
                              <a:rPr lang="en-US" b="0" i="1" smtClean="0"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US" b="0" i="1" smtClean="0">
                                <a:latin typeface="Cambria Math" panose="02040503050406030204" pitchFamily="18" charset="0"/>
                              </a:rPr>
                              <m:t>𝑂</m:t>
                            </m:r>
                          </m:e>
                          <m:sub>
                            <m:r>
                              <a:rPr lang="en-US" b="0" i="1" smtClean="0">
                                <a:latin typeface="Cambria Math" panose="02040503050406030204" pitchFamily="18" charset="0"/>
                              </a:rPr>
                              <m:t>2</m:t>
                            </m:r>
                          </m:sub>
                        </m:sSub>
                      </m:num>
                      <m:den>
                        <m:r>
                          <a:rPr lang="en-US" b="0" i="1" smtClean="0">
                            <a:latin typeface="Cambria Math" panose="02040503050406030204" pitchFamily="18" charset="0"/>
                          </a:rPr>
                          <m:t>𝑚𝑖𝑛</m:t>
                        </m:r>
                      </m:den>
                    </m:f>
                  </m:oMath>
                </a14:m>
                <a:r>
                  <a:rPr lang="en-US" dirty="0"/>
                  <a:t>  consumed by 2.81*10</a:t>
                </a:r>
                <a:r>
                  <a:rPr lang="en-US" baseline="30000" dirty="0"/>
                  <a:t>8</a:t>
                </a:r>
                <a:r>
                  <a:rPr lang="en-US" dirty="0"/>
                  <a:t> iPSCs</a:t>
                </a:r>
              </a:p>
              <a:p>
                <a:endParaRPr lang="en-US" dirty="0"/>
              </a:p>
              <a:p>
                <a14:m>
                  <m:oMath xmlns:m="http://schemas.openxmlformats.org/officeDocument/2006/math">
                    <m:f>
                      <m:fPr>
                        <m:ctrlPr>
                          <a:rPr lang="en-US" b="0" i="1" smtClean="0">
                            <a:latin typeface="Cambria Math" panose="02040503050406030204" pitchFamily="18" charset="0"/>
                          </a:rPr>
                        </m:ctrlPr>
                      </m:fPr>
                      <m:num>
                        <m:r>
                          <a:rPr lang="en-US" b="0" i="1" smtClean="0">
                            <a:latin typeface="Cambria Math" panose="02040503050406030204" pitchFamily="18" charset="0"/>
                          </a:rPr>
                          <m:t>2.75∗</m:t>
                        </m:r>
                        <m:sSup>
                          <m:sSupPr>
                            <m:ctrlPr>
                              <a:rPr lang="en-US" b="0" i="1" smtClean="0">
                                <a:latin typeface="Cambria Math" panose="02040503050406030204" pitchFamily="18" charset="0"/>
                              </a:rPr>
                            </m:ctrlPr>
                          </m:sSupPr>
                          <m:e>
                            <m:r>
                              <a:rPr lang="en-US" b="0" i="1" smtClean="0">
                                <a:latin typeface="Cambria Math" panose="02040503050406030204" pitchFamily="18" charset="0"/>
                              </a:rPr>
                              <m:t>10</m:t>
                            </m:r>
                          </m:e>
                          <m:sup>
                            <m:r>
                              <a:rPr lang="en-US" b="0" i="1" smtClean="0">
                                <a:latin typeface="Cambria Math" panose="02040503050406030204" pitchFamily="18" charset="0"/>
                              </a:rPr>
                              <m:t>−7</m:t>
                            </m:r>
                          </m:sup>
                        </m:sSup>
                        <m:f>
                          <m:fPr>
                            <m:ctrlPr>
                              <a:rPr lang="en-US" b="0" i="1" smtClean="0">
                                <a:latin typeface="Cambria Math" panose="02040503050406030204" pitchFamily="18" charset="0"/>
                              </a:rPr>
                            </m:ctrlPr>
                          </m:fPr>
                          <m:num>
                            <m:r>
                              <a:rPr lang="en-US" b="0" i="1" smtClean="0">
                                <a:latin typeface="Cambria Math" panose="02040503050406030204" pitchFamily="18" charset="0"/>
                              </a:rPr>
                              <m:t>𝑚𝑜𝑙</m:t>
                            </m:r>
                            <m:sSub>
                              <m:sSubPr>
                                <m:ctrlPr>
                                  <a:rPr lang="en-US" b="0" i="1" smtClean="0">
                                    <a:latin typeface="Cambria Math" panose="02040503050406030204" pitchFamily="18" charset="0"/>
                                  </a:rPr>
                                </m:ctrlPr>
                              </m:sSubPr>
                              <m:e>
                                <m:r>
                                  <a:rPr lang="en-US" b="0" i="1" smtClean="0">
                                    <a:latin typeface="Cambria Math" panose="02040503050406030204" pitchFamily="18" charset="0"/>
                                  </a:rPr>
                                  <m:t>𝑂</m:t>
                                </m:r>
                              </m:e>
                              <m:sub>
                                <m:r>
                                  <a:rPr lang="en-US" b="0" i="1" smtClean="0">
                                    <a:latin typeface="Cambria Math" panose="02040503050406030204" pitchFamily="18" charset="0"/>
                                  </a:rPr>
                                  <m:t>2</m:t>
                                </m:r>
                              </m:sub>
                            </m:sSub>
                          </m:num>
                          <m:den>
                            <m:r>
                              <a:rPr lang="en-US" b="0" i="1" smtClean="0">
                                <a:latin typeface="Cambria Math" panose="02040503050406030204" pitchFamily="18" charset="0"/>
                              </a:rPr>
                              <m:t>𝑚𝑖𝑛</m:t>
                            </m:r>
                          </m:den>
                        </m:f>
                      </m:num>
                      <m:den>
                        <m:r>
                          <a:rPr lang="en-US" b="0" i="1" smtClean="0">
                            <a:latin typeface="Cambria Math" panose="02040503050406030204" pitchFamily="18" charset="0"/>
                          </a:rPr>
                          <m:t>2.81∗</m:t>
                        </m:r>
                        <m:sSup>
                          <m:sSupPr>
                            <m:ctrlPr>
                              <a:rPr lang="en-US" b="0" i="1" smtClean="0">
                                <a:latin typeface="Cambria Math" panose="02040503050406030204" pitchFamily="18" charset="0"/>
                              </a:rPr>
                            </m:ctrlPr>
                          </m:sSupPr>
                          <m:e>
                            <m:r>
                              <a:rPr lang="en-US" b="0" i="1" smtClean="0">
                                <a:latin typeface="Cambria Math" panose="02040503050406030204" pitchFamily="18" charset="0"/>
                              </a:rPr>
                              <m:t>10</m:t>
                            </m:r>
                          </m:e>
                          <m:sup>
                            <m:r>
                              <a:rPr lang="en-US" b="0" i="1" smtClean="0">
                                <a:latin typeface="Cambria Math" panose="02040503050406030204" pitchFamily="18" charset="0"/>
                              </a:rPr>
                              <m:t>8</m:t>
                            </m:r>
                          </m:sup>
                        </m:sSup>
                        <m:r>
                          <a:rPr lang="en-US" b="0" i="1" smtClean="0">
                            <a:latin typeface="Cambria Math" panose="02040503050406030204" pitchFamily="18" charset="0"/>
                          </a:rPr>
                          <m:t> </m:t>
                        </m:r>
                        <m:r>
                          <a:rPr lang="en-US" b="0" i="1" smtClean="0">
                            <a:latin typeface="Cambria Math" panose="02040503050406030204" pitchFamily="18" charset="0"/>
                          </a:rPr>
                          <m:t>𝑐𝑒𝑙𝑙𝑠</m:t>
                        </m:r>
                      </m:den>
                    </m:f>
                    <m:r>
                      <a:rPr lang="en-US" i="1" smtClean="0">
                        <a:latin typeface="Cambria Math" panose="02040503050406030204" pitchFamily="18" charset="0"/>
                      </a:rPr>
                      <m:t>=</m:t>
                    </m:r>
                    <m:r>
                      <a:rPr lang="en-US" b="0" i="1" smtClean="0">
                        <a:latin typeface="Cambria Math" panose="02040503050406030204" pitchFamily="18" charset="0"/>
                      </a:rPr>
                      <m:t>1.06∗</m:t>
                    </m:r>
                    <m:sSup>
                      <m:sSupPr>
                        <m:ctrlPr>
                          <a:rPr lang="en-US" b="0" i="1" smtClean="0">
                            <a:latin typeface="Cambria Math" panose="02040503050406030204" pitchFamily="18" charset="0"/>
                          </a:rPr>
                        </m:ctrlPr>
                      </m:sSupPr>
                      <m:e>
                        <m:r>
                          <a:rPr lang="en-US" b="0" i="1" smtClean="0">
                            <a:latin typeface="Cambria Math" panose="02040503050406030204" pitchFamily="18" charset="0"/>
                          </a:rPr>
                          <m:t>10</m:t>
                        </m:r>
                      </m:e>
                      <m:sup>
                        <m:r>
                          <a:rPr lang="en-US" b="0" i="1" smtClean="0">
                            <a:latin typeface="Cambria Math" panose="02040503050406030204" pitchFamily="18" charset="0"/>
                          </a:rPr>
                          <m:t>−15</m:t>
                        </m:r>
                      </m:sup>
                    </m:sSup>
                    <m:f>
                      <m:fPr>
                        <m:ctrlPr>
                          <a:rPr lang="en-US" b="0" i="1" smtClean="0">
                            <a:latin typeface="Cambria Math" panose="02040503050406030204" pitchFamily="18" charset="0"/>
                          </a:rPr>
                        </m:ctrlPr>
                      </m:fPr>
                      <m:num>
                        <m:r>
                          <a:rPr lang="en-US" b="0" i="1" smtClean="0">
                            <a:latin typeface="Cambria Math" panose="02040503050406030204" pitchFamily="18" charset="0"/>
                          </a:rPr>
                          <m:t>𝑚𝑜𝑙</m:t>
                        </m:r>
                        <m:r>
                          <a:rPr lang="en-US" b="0" i="1" smtClean="0">
                            <a:latin typeface="Cambria Math" panose="02040503050406030204" pitchFamily="18" charset="0"/>
                          </a:rPr>
                          <m:t> </m:t>
                        </m:r>
                        <m:sSub>
                          <m:sSubPr>
                            <m:ctrlPr>
                              <a:rPr lang="en-US" b="0" i="1" smtClean="0"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US" b="0" i="1" smtClean="0">
                                <a:latin typeface="Cambria Math" panose="02040503050406030204" pitchFamily="18" charset="0"/>
                              </a:rPr>
                              <m:t>𝑂</m:t>
                            </m:r>
                          </m:e>
                          <m:sub>
                            <m:r>
                              <a:rPr lang="en-US" b="0" i="1" smtClean="0">
                                <a:latin typeface="Cambria Math" panose="02040503050406030204" pitchFamily="18" charset="0"/>
                              </a:rPr>
                              <m:t>2</m:t>
                            </m:r>
                          </m:sub>
                        </m:sSub>
                      </m:num>
                      <m:den>
                        <m:func>
                          <m:funcPr>
                            <m:ctrlPr>
                              <a:rPr lang="en-US" b="0" i="1" smtClean="0">
                                <a:latin typeface="Cambria Math" panose="02040503050406030204" pitchFamily="18" charset="0"/>
                              </a:rPr>
                            </m:ctrlPr>
                          </m:funcPr>
                          <m:fName>
                            <m:r>
                              <m:rPr>
                                <m:sty m:val="p"/>
                              </m:rPr>
                              <a:rPr lang="en-US" b="0" i="0" smtClean="0">
                                <a:latin typeface="Cambria Math" panose="02040503050406030204" pitchFamily="18" charset="0"/>
                              </a:rPr>
                              <m:t>min</m:t>
                            </m:r>
                          </m:fName>
                          <m:e>
                            <m:r>
                              <a:rPr lang="en-US" b="0" i="1" smtClean="0">
                                <a:latin typeface="Cambria Math" panose="02040503050406030204" pitchFamily="18" charset="0"/>
                              </a:rPr>
                              <m:t> ∗</m:t>
                            </m:r>
                            <m:r>
                              <a:rPr lang="en-US" b="0" i="1" smtClean="0">
                                <a:latin typeface="Cambria Math" panose="02040503050406030204" pitchFamily="18" charset="0"/>
                              </a:rPr>
                              <m:t>𝑐𝑒𝑙𝑙𝑠</m:t>
                            </m:r>
                          </m:e>
                        </m:func>
                      </m:den>
                    </m:f>
                    <m:r>
                      <a:rPr lang="en-US" b="0" i="0" smtClean="0">
                        <a:latin typeface="Cambria Math" panose="02040503050406030204" pitchFamily="18" charset="0"/>
                      </a:rPr>
                      <m:t>=17.77 </m:t>
                    </m:r>
                    <m:f>
                      <m:fPr>
                        <m:ctrlPr>
                          <a:rPr lang="en-US" b="0" i="1" smtClean="0">
                            <a:latin typeface="Cambria Math" panose="02040503050406030204" pitchFamily="18" charset="0"/>
                          </a:rPr>
                        </m:ctrlPr>
                      </m:fPr>
                      <m:num>
                        <m:r>
                          <a:rPr lang="en-US" b="0" i="1" smtClean="0">
                            <a:latin typeface="Cambria Math" panose="02040503050406030204" pitchFamily="18" charset="0"/>
                          </a:rPr>
                          <m:t>𝑎𝑚𝑜𝑙</m:t>
                        </m:r>
                      </m:num>
                      <m:den>
                        <m:r>
                          <a:rPr lang="en-US" b="0" i="1" smtClean="0">
                            <a:latin typeface="Cambria Math" panose="02040503050406030204" pitchFamily="18" charset="0"/>
                          </a:rPr>
                          <m:t>𝑠</m:t>
                        </m:r>
                        <m:r>
                          <a:rPr lang="en-US" b="0" i="1" smtClean="0">
                            <a:latin typeface="Cambria Math" panose="02040503050406030204" pitchFamily="18" charset="0"/>
                          </a:rPr>
                          <m:t> ∗</m:t>
                        </m:r>
                        <m:r>
                          <a:rPr lang="en-US" b="0" i="1" smtClean="0">
                            <a:latin typeface="Cambria Math" panose="02040503050406030204" pitchFamily="18" charset="0"/>
                          </a:rPr>
                          <m:t>𝑐𝑒𝑙𝑙𝑠</m:t>
                        </m:r>
                      </m:den>
                    </m:f>
                  </m:oMath>
                </a14:m>
                <a:r>
                  <a:rPr lang="en-US" dirty="0"/>
                  <a:t> = </a:t>
                </a:r>
                <a:r>
                  <a:rPr lang="en-US" dirty="0" err="1"/>
                  <a:t>sOUR</a:t>
                </a:r>
                <a:r>
                  <a:rPr lang="en-US" dirty="0"/>
                  <a:t> of iPSCs</a:t>
                </a:r>
              </a:p>
            </p:txBody>
          </p:sp>
        </mc:Choice>
        <mc:Fallback xmlns=""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106A69B4-B2EE-FD7F-6AE0-2406EE274440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2404785" y="3262544"/>
                <a:ext cx="7606506" cy="1262974"/>
              </a:xfrm>
              <a:prstGeom prst="rect">
                <a:avLst/>
              </a:prstGeom>
              <a:blipFill>
                <a:blip r:embed="rId3"/>
                <a:stretch>
                  <a:fillRect r="-1042" b="-6763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</p:spTree>
    <p:extLst>
      <p:ext uri="{BB962C8B-B14F-4D97-AF65-F5344CB8AC3E}">
        <p14:creationId xmlns:p14="http://schemas.microsoft.com/office/powerpoint/2010/main" val="53578191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F5A89918-62DB-0F2D-4E27-A0BDF4E0CF2D}"/>
              </a:ext>
            </a:extLst>
          </p:cNvPr>
          <p:cNvSpPr txBox="1"/>
          <p:nvPr/>
        </p:nvSpPr>
        <p:spPr>
          <a:xfrm>
            <a:off x="896112" y="823240"/>
            <a:ext cx="5052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</a:t>
            </a:r>
            <a:r>
              <a:rPr lang="en-US" b="1" dirty="0"/>
              <a:t>a</a:t>
            </a:r>
            <a:r>
              <a:rPr lang="en-US" dirty="0"/>
              <a:t>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54D98A3-52D8-AD25-50F2-C9F987942963}"/>
              </a:ext>
            </a:extLst>
          </p:cNvPr>
          <p:cNvSpPr txBox="1"/>
          <p:nvPr/>
        </p:nvSpPr>
        <p:spPr>
          <a:xfrm>
            <a:off x="5996820" y="823240"/>
            <a:ext cx="5052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</a:t>
            </a:r>
            <a:r>
              <a:rPr lang="en-US" b="1" dirty="0"/>
              <a:t>b</a:t>
            </a:r>
            <a:r>
              <a:rPr lang="en-US" dirty="0"/>
              <a:t>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728ECAA-D379-EE7D-D6EE-346DF4DEF768}"/>
              </a:ext>
            </a:extLst>
          </p:cNvPr>
          <p:cNvSpPr txBox="1"/>
          <p:nvPr/>
        </p:nvSpPr>
        <p:spPr>
          <a:xfrm>
            <a:off x="896112" y="2407641"/>
            <a:ext cx="5052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</a:t>
            </a:r>
            <a:r>
              <a:rPr lang="en-US" b="1" dirty="0"/>
              <a:t>c</a:t>
            </a:r>
            <a:r>
              <a:rPr lang="en-US" dirty="0"/>
              <a:t>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6A1C57C-3515-427E-BD9D-159F7D46111E}"/>
              </a:ext>
            </a:extLst>
          </p:cNvPr>
          <p:cNvSpPr txBox="1"/>
          <p:nvPr/>
        </p:nvSpPr>
        <p:spPr>
          <a:xfrm>
            <a:off x="5996820" y="2407641"/>
            <a:ext cx="5052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</a:t>
            </a:r>
            <a:r>
              <a:rPr lang="en-US" b="1" dirty="0"/>
              <a:t>d</a:t>
            </a:r>
            <a:r>
              <a:rPr lang="en-US" dirty="0"/>
              <a:t>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9796F3A-E9CD-AF3D-CAC3-A0724822F8EA}"/>
              </a:ext>
            </a:extLst>
          </p:cNvPr>
          <p:cNvSpPr txBox="1"/>
          <p:nvPr/>
        </p:nvSpPr>
        <p:spPr>
          <a:xfrm>
            <a:off x="896112" y="3996597"/>
            <a:ext cx="5052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</a:t>
            </a:r>
            <a:r>
              <a:rPr lang="en-US" b="1" dirty="0"/>
              <a:t>e</a:t>
            </a:r>
            <a:r>
              <a:rPr lang="en-US" dirty="0"/>
              <a:t>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AF8D8F0-2D1D-F04F-6A09-44F75CABD5E9}"/>
              </a:ext>
            </a:extLst>
          </p:cNvPr>
          <p:cNvSpPr txBox="1"/>
          <p:nvPr/>
        </p:nvSpPr>
        <p:spPr>
          <a:xfrm>
            <a:off x="5996820" y="4177886"/>
            <a:ext cx="5052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</a:t>
            </a:r>
            <a:r>
              <a:rPr lang="en-US" b="1" dirty="0"/>
              <a:t>f</a:t>
            </a:r>
            <a:r>
              <a:rPr lang="en-US" dirty="0"/>
              <a:t>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3ED60A9-1FB3-76A3-D63C-C4D86B8A7790}"/>
              </a:ext>
            </a:extLst>
          </p:cNvPr>
          <p:cNvSpPr txBox="1"/>
          <p:nvPr/>
        </p:nvSpPr>
        <p:spPr>
          <a:xfrm>
            <a:off x="1468134" y="5586984"/>
            <a:ext cx="95214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2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Summary of the maximum cell density before oxygen limitation calculated in PBS 3 at (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2L , (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3L, PBS 15 at (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10L, (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15L, PBS 80 at (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50L and (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80L working volume.</a:t>
            </a:r>
          </a:p>
        </p:txBody>
      </p:sp>
      <p:graphicFrame>
        <p:nvGraphicFramePr>
          <p:cNvPr id="20" name="Table 19">
            <a:extLst>
              <a:ext uri="{FF2B5EF4-FFF2-40B4-BE49-F238E27FC236}">
                <a16:creationId xmlns:a16="http://schemas.microsoft.com/office/drawing/2014/main" id="{852302D9-EE05-B8A1-D64D-879FB0D78E3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46077605"/>
              </p:ext>
            </p:extLst>
          </p:nvPr>
        </p:nvGraphicFramePr>
        <p:xfrm>
          <a:off x="1468134" y="824298"/>
          <a:ext cx="4267200" cy="13335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09600">
                  <a:extLst>
                    <a:ext uri="{9D8B030D-6E8A-4147-A177-3AD203B41FA5}">
                      <a16:colId xmlns:a16="http://schemas.microsoft.com/office/drawing/2014/main" val="3054457909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991361326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480315010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423969594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01762805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557333772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693992519"/>
                    </a:ext>
                  </a:extLst>
                </a:gridCol>
              </a:tblGrid>
              <a:tr h="190500">
                <a:tc rowSpan="2" gridSpan="2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ximum Cell Density [cells/mL]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s Flow Rate [LPM]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10075466"/>
                  </a:ext>
                </a:extLst>
              </a:tr>
              <a:tr h="190500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56460264"/>
                  </a:ext>
                </a:extLst>
              </a:tr>
              <a:tr h="190500">
                <a:tc rowSpan="5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itation rat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vert="vert27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15E+0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31E+0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40E+0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90E+0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82E+06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301513207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56E+0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06E+0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81E+0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80E+0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89E+06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481857170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4E+0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4E+0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6E+0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5E+0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4E+07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209465546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3E+0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5E+0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4E+0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4E+0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1E+07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357514298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8E+0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9E+0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9E+0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7E+0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1E+07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599977736"/>
                  </a:ext>
                </a:extLst>
              </a:tr>
            </a:tbl>
          </a:graphicData>
        </a:graphic>
      </p:graphicFrame>
      <p:graphicFrame>
        <p:nvGraphicFramePr>
          <p:cNvPr id="22" name="Table 21">
            <a:extLst>
              <a:ext uri="{FF2B5EF4-FFF2-40B4-BE49-F238E27FC236}">
                <a16:creationId xmlns:a16="http://schemas.microsoft.com/office/drawing/2014/main" id="{711D95A7-9B7A-9B13-6E3C-78D856DA610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19732055"/>
              </p:ext>
            </p:extLst>
          </p:nvPr>
        </p:nvGraphicFramePr>
        <p:xfrm>
          <a:off x="6608062" y="817970"/>
          <a:ext cx="4267200" cy="13335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09600">
                  <a:extLst>
                    <a:ext uri="{9D8B030D-6E8A-4147-A177-3AD203B41FA5}">
                      <a16:colId xmlns:a16="http://schemas.microsoft.com/office/drawing/2014/main" val="1331379427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652815491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592671801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774087519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085081505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221263303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4150290261"/>
                    </a:ext>
                  </a:extLst>
                </a:gridCol>
              </a:tblGrid>
              <a:tr h="190500">
                <a:tc rowSpan="2" grid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ximum Cell Density [cells/mL]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s Flow Rate [LPM]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93873641"/>
                  </a:ext>
                </a:extLst>
              </a:tr>
              <a:tr h="190500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17983777"/>
                  </a:ext>
                </a:extLst>
              </a:tr>
              <a:tr h="190500">
                <a:tc rowSpan="5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itation rat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vert="vert27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91E+0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66E+0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91E+0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16E+0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24E+06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199195405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32E+0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32E+0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65E+0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48E+0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07E+06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187488134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23E+0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31E+0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06E+0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31E+0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81E+06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1679006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14E+0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22E+0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38E+0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63E+0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55E+06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911875890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97E+0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47E+0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97E+0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5E+0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5E+07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871256891"/>
                  </a:ext>
                </a:extLst>
              </a:tr>
            </a:tbl>
          </a:graphicData>
        </a:graphic>
      </p:graphicFrame>
      <p:graphicFrame>
        <p:nvGraphicFramePr>
          <p:cNvPr id="23" name="Table 22">
            <a:extLst>
              <a:ext uri="{FF2B5EF4-FFF2-40B4-BE49-F238E27FC236}">
                <a16:creationId xmlns:a16="http://schemas.microsoft.com/office/drawing/2014/main" id="{9950158C-E7DA-E2F5-B041-72FA2ED1D8E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57809659"/>
              </p:ext>
            </p:extLst>
          </p:nvPr>
        </p:nvGraphicFramePr>
        <p:xfrm>
          <a:off x="1468134" y="2407641"/>
          <a:ext cx="4267200" cy="13335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09600">
                  <a:extLst>
                    <a:ext uri="{9D8B030D-6E8A-4147-A177-3AD203B41FA5}">
                      <a16:colId xmlns:a16="http://schemas.microsoft.com/office/drawing/2014/main" val="649752887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4205152558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180961555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836528533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470000689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770766882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4267747018"/>
                    </a:ext>
                  </a:extLst>
                </a:gridCol>
              </a:tblGrid>
              <a:tr h="190500">
                <a:tc rowSpan="2" grid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ximum Cell Density [cells/mL]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s Flow Rate [LPM]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39739789"/>
                  </a:ext>
                </a:extLst>
              </a:tr>
              <a:tr h="190500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190393104"/>
                  </a:ext>
                </a:extLst>
              </a:tr>
              <a:tr h="190500">
                <a:tc rowSpan="5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itation rat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vert="vert27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91E+0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57E+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90E+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49E+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57E+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664895115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65E+0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56E+0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40E+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56E+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90E+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514673365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64E+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97E+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9E+0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3E+0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14E+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138844468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8E+0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0E+0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3E+0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1E+0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8E+0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243639058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9E+0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94E+0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09E+0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12E+0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73E+0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922338923"/>
                  </a:ext>
                </a:extLst>
              </a:tr>
            </a:tbl>
          </a:graphicData>
        </a:graphic>
      </p:graphicFrame>
      <p:graphicFrame>
        <p:nvGraphicFramePr>
          <p:cNvPr id="24" name="Table 23">
            <a:extLst>
              <a:ext uri="{FF2B5EF4-FFF2-40B4-BE49-F238E27FC236}">
                <a16:creationId xmlns:a16="http://schemas.microsoft.com/office/drawing/2014/main" id="{690287F5-AB4A-EC4A-AB84-44BAEF3CC12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78596417"/>
              </p:ext>
            </p:extLst>
          </p:nvPr>
        </p:nvGraphicFramePr>
        <p:xfrm>
          <a:off x="6608062" y="2412912"/>
          <a:ext cx="4267200" cy="13335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09600">
                  <a:extLst>
                    <a:ext uri="{9D8B030D-6E8A-4147-A177-3AD203B41FA5}">
                      <a16:colId xmlns:a16="http://schemas.microsoft.com/office/drawing/2014/main" val="3816472828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870189294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205909569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40877251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231560829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213727470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197332465"/>
                    </a:ext>
                  </a:extLst>
                </a:gridCol>
              </a:tblGrid>
              <a:tr h="190500">
                <a:tc rowSpan="2" grid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ximum Cell Density [cells/mL]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s Flow Rate [LPM]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05467397"/>
                  </a:ext>
                </a:extLst>
              </a:tr>
              <a:tr h="190500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791893253"/>
                  </a:ext>
                </a:extLst>
              </a:tr>
              <a:tr h="190500">
                <a:tc rowSpan="5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itation rat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vert="vert27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9E+0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8E+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9E+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1E+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3E+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820681142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74E+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82E+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66E+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66E+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82E+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153450466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40E+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40E+0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32E+0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32E+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24E+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930352486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40E+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32E+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57E+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48E+0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90E+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512480399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81E+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47E+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E+0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9E+0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5E+0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241408499"/>
                  </a:ext>
                </a:extLst>
              </a:tr>
            </a:tbl>
          </a:graphicData>
        </a:graphic>
      </p:graphicFrame>
      <p:graphicFrame>
        <p:nvGraphicFramePr>
          <p:cNvPr id="25" name="Table 24">
            <a:extLst>
              <a:ext uri="{FF2B5EF4-FFF2-40B4-BE49-F238E27FC236}">
                <a16:creationId xmlns:a16="http://schemas.microsoft.com/office/drawing/2014/main" id="{D0122E2F-B91F-D9AF-2C6B-1669F489AEA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30611911"/>
              </p:ext>
            </p:extLst>
          </p:nvPr>
        </p:nvGraphicFramePr>
        <p:xfrm>
          <a:off x="1468134" y="3998370"/>
          <a:ext cx="3048000" cy="13335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09600">
                  <a:extLst>
                    <a:ext uri="{9D8B030D-6E8A-4147-A177-3AD203B41FA5}">
                      <a16:colId xmlns:a16="http://schemas.microsoft.com/office/drawing/2014/main" val="906298763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353106815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664074589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490957000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93126975"/>
                    </a:ext>
                  </a:extLst>
                </a:gridCol>
              </a:tblGrid>
              <a:tr h="190500">
                <a:tc rowSpan="2" grid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ximum Cell Density [cells/mL]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s Flow Rate [LPM]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72581130"/>
                  </a:ext>
                </a:extLst>
              </a:tr>
              <a:tr h="190500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041829252"/>
                  </a:ext>
                </a:extLst>
              </a:tr>
              <a:tr h="190500">
                <a:tc rowSpan="5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itation rat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vert="vert27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1E+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3E+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4E+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552208752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48E+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07E+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65E+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423138156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47E+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80E+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22E+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917710129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5E+0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0E+0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7E+0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780005948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2E+0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1E+0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4E+0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345190469"/>
                  </a:ext>
                </a:extLst>
              </a:tr>
            </a:tbl>
          </a:graphicData>
        </a:graphic>
      </p:graphicFrame>
      <p:graphicFrame>
        <p:nvGraphicFramePr>
          <p:cNvPr id="26" name="Table 25">
            <a:extLst>
              <a:ext uri="{FF2B5EF4-FFF2-40B4-BE49-F238E27FC236}">
                <a16:creationId xmlns:a16="http://schemas.microsoft.com/office/drawing/2014/main" id="{4C34C4D7-A258-8221-9F47-997717B4042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00477165"/>
              </p:ext>
            </p:extLst>
          </p:nvPr>
        </p:nvGraphicFramePr>
        <p:xfrm>
          <a:off x="6608062" y="3992042"/>
          <a:ext cx="3048000" cy="13335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09600">
                  <a:extLst>
                    <a:ext uri="{9D8B030D-6E8A-4147-A177-3AD203B41FA5}">
                      <a16:colId xmlns:a16="http://schemas.microsoft.com/office/drawing/2014/main" val="313710190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4469598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878807724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164523645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438597852"/>
                    </a:ext>
                  </a:extLst>
                </a:gridCol>
              </a:tblGrid>
              <a:tr h="190500">
                <a:tc rowSpan="2" gridSpan="2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ximum Cell Density [cells/mL]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s Flow Rate [LPM]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00177389"/>
                  </a:ext>
                </a:extLst>
              </a:tr>
              <a:tr h="190500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231686067"/>
                  </a:ext>
                </a:extLst>
              </a:tr>
              <a:tr h="190500">
                <a:tc rowSpan="5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itation rat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vert="vert27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47E+0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30E+0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14E+05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218044079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3E+0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3E+0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9E+06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078122671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8E+0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66E+0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41E+06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96888601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99E+0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07E+0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15E+06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952875898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23E+0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07E+0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15E+06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94741436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29027193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1084622-58DC-C5D7-98F1-38625534F39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1CA5D6E9-CE7C-1CD1-77F2-2DD68DD9E848}"/>
              </a:ext>
            </a:extLst>
          </p:cNvPr>
          <p:cNvSpPr txBox="1"/>
          <p:nvPr/>
        </p:nvSpPr>
        <p:spPr>
          <a:xfrm>
            <a:off x="896112" y="823240"/>
            <a:ext cx="5052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</a:t>
            </a:r>
            <a:r>
              <a:rPr lang="en-US" b="1" dirty="0"/>
              <a:t>a</a:t>
            </a:r>
            <a:r>
              <a:rPr lang="en-US" dirty="0"/>
              <a:t>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CD01374-B56A-E238-C4C6-26973071C660}"/>
              </a:ext>
            </a:extLst>
          </p:cNvPr>
          <p:cNvSpPr txBox="1"/>
          <p:nvPr/>
        </p:nvSpPr>
        <p:spPr>
          <a:xfrm>
            <a:off x="5996820" y="823240"/>
            <a:ext cx="5052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</a:t>
            </a:r>
            <a:r>
              <a:rPr lang="en-US" b="1" dirty="0"/>
              <a:t>b</a:t>
            </a:r>
            <a:r>
              <a:rPr lang="en-US" dirty="0"/>
              <a:t>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7644B8C-3C04-CFA7-EDE3-553588BF792D}"/>
              </a:ext>
            </a:extLst>
          </p:cNvPr>
          <p:cNvSpPr txBox="1"/>
          <p:nvPr/>
        </p:nvSpPr>
        <p:spPr>
          <a:xfrm>
            <a:off x="896112" y="2407641"/>
            <a:ext cx="5052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</a:t>
            </a:r>
            <a:r>
              <a:rPr lang="en-US" b="1" dirty="0"/>
              <a:t>c</a:t>
            </a:r>
            <a:r>
              <a:rPr lang="en-US" dirty="0"/>
              <a:t>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2F903C6-D786-72D4-062B-757C12EC462A}"/>
              </a:ext>
            </a:extLst>
          </p:cNvPr>
          <p:cNvSpPr txBox="1"/>
          <p:nvPr/>
        </p:nvSpPr>
        <p:spPr>
          <a:xfrm>
            <a:off x="5996820" y="2407641"/>
            <a:ext cx="5052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</a:t>
            </a:r>
            <a:r>
              <a:rPr lang="en-US" b="1" dirty="0"/>
              <a:t>d</a:t>
            </a:r>
            <a:r>
              <a:rPr lang="en-US" dirty="0"/>
              <a:t>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1C502D1-92D8-C6BF-BA40-FEF41661866C}"/>
              </a:ext>
            </a:extLst>
          </p:cNvPr>
          <p:cNvSpPr txBox="1"/>
          <p:nvPr/>
        </p:nvSpPr>
        <p:spPr>
          <a:xfrm>
            <a:off x="896112" y="3996597"/>
            <a:ext cx="5052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</a:t>
            </a:r>
            <a:r>
              <a:rPr lang="en-US" b="1" dirty="0"/>
              <a:t>e</a:t>
            </a:r>
            <a:r>
              <a:rPr lang="en-US" dirty="0"/>
              <a:t>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FBF714F-D6F5-BFDB-2CB7-A6EED1D0199C}"/>
              </a:ext>
            </a:extLst>
          </p:cNvPr>
          <p:cNvSpPr txBox="1"/>
          <p:nvPr/>
        </p:nvSpPr>
        <p:spPr>
          <a:xfrm>
            <a:off x="5996820" y="4177886"/>
            <a:ext cx="5052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</a:t>
            </a:r>
            <a:r>
              <a:rPr lang="en-US" b="1" dirty="0"/>
              <a:t>f</a:t>
            </a:r>
            <a:r>
              <a:rPr lang="en-US" dirty="0"/>
              <a:t>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95DA937-A7C0-19BF-20C9-33999E34CBBD}"/>
              </a:ext>
            </a:extLst>
          </p:cNvPr>
          <p:cNvSpPr txBox="1"/>
          <p:nvPr/>
        </p:nvSpPr>
        <p:spPr>
          <a:xfrm>
            <a:off x="1468134" y="5586984"/>
            <a:ext cx="95214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3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Summary of the maximum cell number before oxygen limitation calculated in PBS 3 at (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2L , (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3L, PBS 15 at (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10L, (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15L, PBS 80 at (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50L and (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80L working volume.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7C71F632-C4BD-BED3-01D1-3C3375572B1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74394610"/>
              </p:ext>
            </p:extLst>
          </p:nvPr>
        </p:nvGraphicFramePr>
        <p:xfrm>
          <a:off x="1468134" y="816912"/>
          <a:ext cx="4267200" cy="13335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09600">
                  <a:extLst>
                    <a:ext uri="{9D8B030D-6E8A-4147-A177-3AD203B41FA5}">
                      <a16:colId xmlns:a16="http://schemas.microsoft.com/office/drawing/2014/main" val="3441695414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264257731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892256014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509107246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791038965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845220405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423116222"/>
                    </a:ext>
                  </a:extLst>
                </a:gridCol>
              </a:tblGrid>
              <a:tr h="190500">
                <a:tc rowSpan="2" gridSpan="2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ximum Cell Numbe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s Flow Rate [LPM]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17871450"/>
                  </a:ext>
                </a:extLst>
              </a:tr>
              <a:tr h="190500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520514747"/>
                  </a:ext>
                </a:extLst>
              </a:tr>
              <a:tr h="190500">
                <a:tc rowSpan="5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itation rat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vert="vert27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30E+0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6E+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8E+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80E+0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63E+09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552408220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1E+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1E+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6E+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6E+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8E+10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963275755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8E+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8E+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3E+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9E+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8E+10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27312853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46E+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69E+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67E+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67E+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62E+10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955945813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16E+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37E+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39E+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74E+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42E+10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687849674"/>
                  </a:ext>
                </a:extLst>
              </a:tr>
            </a:tbl>
          </a:graphicData>
        </a:graphic>
      </p:graphicFrame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1EB73523-914C-D4A6-AF6E-0A7BA2044D1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3338605"/>
              </p:ext>
            </p:extLst>
          </p:nvPr>
        </p:nvGraphicFramePr>
        <p:xfrm>
          <a:off x="6608062" y="816912"/>
          <a:ext cx="4267200" cy="13335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09600">
                  <a:extLst>
                    <a:ext uri="{9D8B030D-6E8A-4147-A177-3AD203B41FA5}">
                      <a16:colId xmlns:a16="http://schemas.microsoft.com/office/drawing/2014/main" val="3656534789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339360517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942942627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4184645612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121614203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89982603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100606655"/>
                    </a:ext>
                  </a:extLst>
                </a:gridCol>
              </a:tblGrid>
              <a:tr h="190500">
                <a:tc rowSpan="2" grid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ximum Cell Numbe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s Flow Rate [LPM]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24825426"/>
                  </a:ext>
                </a:extLst>
              </a:tr>
              <a:tr h="190500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321852602"/>
                  </a:ext>
                </a:extLst>
              </a:tr>
              <a:tr h="190500">
                <a:tc rowSpan="5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itation rat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vert="vert27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72E+0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97E+0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72E+0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47E+0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72E+09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541798342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0E+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0E+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0E+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5E+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2E+10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381295712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7E+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9E+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2E+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19E+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4E+10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64390408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14E+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47E+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82E+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89E+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87E+10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810179711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9E+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84E+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99E+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14E+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16E+10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743814419"/>
                  </a:ext>
                </a:extLst>
              </a:tr>
            </a:tbl>
          </a:graphicData>
        </a:graphic>
      </p:graphicFrame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157F36E9-A2D4-663C-CF05-4FA14051CCE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87979619"/>
              </p:ext>
            </p:extLst>
          </p:nvPr>
        </p:nvGraphicFramePr>
        <p:xfrm>
          <a:off x="1468134" y="2417809"/>
          <a:ext cx="4267200" cy="13335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09600">
                  <a:extLst>
                    <a:ext uri="{9D8B030D-6E8A-4147-A177-3AD203B41FA5}">
                      <a16:colId xmlns:a16="http://schemas.microsoft.com/office/drawing/2014/main" val="3605644251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083090823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462857482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065491516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236362421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512213403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526428063"/>
                    </a:ext>
                  </a:extLst>
                </a:gridCol>
              </a:tblGrid>
              <a:tr h="190500">
                <a:tc rowSpan="2" grid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ximum Cell Numbe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s Flow Rate [LPM]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89844591"/>
                  </a:ext>
                </a:extLst>
              </a:tr>
              <a:tr h="190500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563184242"/>
                  </a:ext>
                </a:extLst>
              </a:tr>
              <a:tr h="190500">
                <a:tc rowSpan="5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itation rat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vert="vert27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91E+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57E+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90E+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49E+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57E+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702536197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65E+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56E+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40E+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56E+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90E+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36092529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64E+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97E+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9E+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3E+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14E+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205750180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8E+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0E+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3E+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1E+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8E+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612745650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9E+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94E+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09E+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12E+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73E+1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214569538"/>
                  </a:ext>
                </a:extLst>
              </a:tr>
            </a:tbl>
          </a:graphicData>
        </a:graphic>
      </p:graphicFrame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5F7FBF10-8037-10B1-0B3A-3984058E9CB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99947509"/>
              </p:ext>
            </p:extLst>
          </p:nvPr>
        </p:nvGraphicFramePr>
        <p:xfrm>
          <a:off x="6608062" y="2404477"/>
          <a:ext cx="4267200" cy="13335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09600">
                  <a:extLst>
                    <a:ext uri="{9D8B030D-6E8A-4147-A177-3AD203B41FA5}">
                      <a16:colId xmlns:a16="http://schemas.microsoft.com/office/drawing/2014/main" val="2738385406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604170657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012676901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917009584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464408794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456080039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829278995"/>
                    </a:ext>
                  </a:extLst>
                </a:gridCol>
              </a:tblGrid>
              <a:tr h="190500">
                <a:tc rowSpan="2" grid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ximum Cell Numbe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s Flow Rate [LPM]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87905199"/>
                  </a:ext>
                </a:extLst>
              </a:tr>
              <a:tr h="190500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068762603"/>
                  </a:ext>
                </a:extLst>
              </a:tr>
              <a:tr h="190500">
                <a:tc rowSpan="5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itation rat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vert="vert27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4E+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7E+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99E+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87E+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74E+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326644405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11E+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24E+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99E+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99E+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24E+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880747568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11E+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11E+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98E+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98E+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86E+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473994162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60E+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48E+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85E+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73E+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85E+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37750291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7E+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2E+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1E+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3E+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8E+1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98950970"/>
                  </a:ext>
                </a:extLst>
              </a:tr>
            </a:tbl>
          </a:graphicData>
        </a:graphic>
      </p:graphicFrame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2570C196-1644-1F6E-8693-DD085D4DE59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92238743"/>
              </p:ext>
            </p:extLst>
          </p:nvPr>
        </p:nvGraphicFramePr>
        <p:xfrm>
          <a:off x="1468134" y="3995731"/>
          <a:ext cx="3048000" cy="13335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09600">
                  <a:extLst>
                    <a:ext uri="{9D8B030D-6E8A-4147-A177-3AD203B41FA5}">
                      <a16:colId xmlns:a16="http://schemas.microsoft.com/office/drawing/2014/main" val="3057001127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963610924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880098435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304190821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445484760"/>
                    </a:ext>
                  </a:extLst>
                </a:gridCol>
              </a:tblGrid>
              <a:tr h="190500">
                <a:tc rowSpan="2" grid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ximum Cell Numbe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s Flow Rate [LPM]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61320786"/>
                  </a:ext>
                </a:extLst>
              </a:tr>
              <a:tr h="190500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7517247"/>
                  </a:ext>
                </a:extLst>
              </a:tr>
              <a:tr h="190500">
                <a:tc rowSpan="5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itation rat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vert="vert27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55E+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6E+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2E+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696999374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4E+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3E+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3E+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463895407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24E+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40E+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61E+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224806726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73E+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48E+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35E+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175383011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60E+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06E+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22E+1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24835130"/>
                  </a:ext>
                </a:extLst>
              </a:tr>
            </a:tbl>
          </a:graphicData>
        </a:graphic>
      </p:graphicFrame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6D786555-3312-1DA3-87CB-4B981548DDD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57476246"/>
              </p:ext>
            </p:extLst>
          </p:nvPr>
        </p:nvGraphicFramePr>
        <p:xfrm>
          <a:off x="6610108" y="3995731"/>
          <a:ext cx="3048000" cy="13335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09600">
                  <a:extLst>
                    <a:ext uri="{9D8B030D-6E8A-4147-A177-3AD203B41FA5}">
                      <a16:colId xmlns:a16="http://schemas.microsoft.com/office/drawing/2014/main" val="434399831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515744442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973047106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070492552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014054251"/>
                    </a:ext>
                  </a:extLst>
                </a:gridCol>
              </a:tblGrid>
              <a:tr h="190500">
                <a:tc rowSpan="2" grid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ximum Cell Numbe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s Flow Rate [LPM]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67110336"/>
                  </a:ext>
                </a:extLst>
              </a:tr>
              <a:tr h="190500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68806212"/>
                  </a:ext>
                </a:extLst>
              </a:tr>
              <a:tr h="190500">
                <a:tc rowSpan="5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itation rat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vert="vert27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74E+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15E+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57E+10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951953592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64E+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64E+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97E+10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561761555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4E+1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3E+1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0E+11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111721339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9E+1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3E+1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8E+11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354087275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62E+1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3E+1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7E+11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03673478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5730516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1</TotalTime>
  <Words>1676</Words>
  <Application>Microsoft Office PowerPoint</Application>
  <PresentationFormat>Widescreen</PresentationFormat>
  <Paragraphs>641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2" baseType="lpstr">
      <vt:lpstr>Aptos</vt:lpstr>
      <vt:lpstr>Aptos Display</vt:lpstr>
      <vt:lpstr>Arial</vt:lpstr>
      <vt:lpstr>Cambria Math</vt:lpstr>
      <vt:lpstr>Palatino Linotype</vt:lpstr>
      <vt:lpstr>Times New Roman</vt:lpstr>
      <vt:lpstr>Office Theme</vt:lpstr>
      <vt:lpstr>Measurement of oxygen transfer rate and specific oxygen uptake rate of h-iPSC aggregates in vertical wheel bioreactors to predict maximum cell density before oxygen limitation  James Kim, Omokhowa Agbojo, Sunghoon Jung, Matt Croughan  Supplementary Materials</vt:lpstr>
      <vt:lpstr>PowerPoint Presentation</vt:lpstr>
      <vt:lpstr>PowerPoint Presentation</vt:lpstr>
      <vt:lpstr>PowerPoint Presentation</vt:lpstr>
      <vt:lpstr>PowerPoint Presentation</vt:lpstr>
    </vt:vector>
  </TitlesOfParts>
  <Company>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ames Kim</dc:creator>
  <cp:lastModifiedBy>James Kim</cp:lastModifiedBy>
  <cp:revision>15</cp:revision>
  <dcterms:created xsi:type="dcterms:W3CDTF">2025-01-08T23:15:51Z</dcterms:created>
  <dcterms:modified xsi:type="dcterms:W3CDTF">2025-03-20T20:29:17Z</dcterms:modified>
</cp:coreProperties>
</file>